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1CA46-A8DF-4083-B646-73478D99B8A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C0FA2-02BE-4136-BE46-555077047A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979829-A676-4788-8887-459ABE61E0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818BFD-4D8A-4672-A8F8-8BBAB04C46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84D55-B232-4E01-9612-3887AAA0C6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A09815-C622-4475-8D63-020D236D51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8B5467-8A11-422D-A099-20ABCD11C1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2E34E-7A1F-4ABB-968C-85063FF2D7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C8D821-8C70-44AC-A814-BFEEF4F683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FBB69-6FDC-4891-9071-5DF25FD0ED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D5FC2-1790-433E-BEF3-03B7C5A0F9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E968D8-5685-4815-BDEE-4E7555C680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45AB7B-02EF-457F-A3CB-A537CAF165E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28760" y="971640"/>
            <a:ext cx="71568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(a)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F</a:t>
            </a:r>
            <a:r>
              <a:rPr b="0" lang="en-US" sz="800" spc="-1" strike="noStrike" baseline="-25000">
                <a:solidFill>
                  <a:srgbClr val="000000"/>
                </a:solidFill>
                <a:latin typeface="Times New Roman"/>
              </a:rPr>
              <a:t>o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and F</a:t>
            </a:r>
            <a:r>
              <a:rPr b="0" lang="en-US" sz="800" spc="-1" strike="noStrike" baseline="-25000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432600" y="971640"/>
            <a:ext cx="74952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(b)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F</a:t>
            </a:r>
            <a:r>
              <a:rPr b="0" lang="en-US" sz="800" spc="-1" strike="noStrike" baseline="-25000">
                <a:solidFill>
                  <a:srgbClr val="000000"/>
                </a:solidFill>
                <a:latin typeface="Times New Roman"/>
              </a:rPr>
              <a:t>s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' and F</a:t>
            </a:r>
            <a:r>
              <a:rPr b="0" lang="en-US" sz="800" spc="-1" strike="noStrike" baseline="-25000">
                <a:solidFill>
                  <a:srgbClr val="000000"/>
                </a:solidFill>
                <a:latin typeface="Times New Roman"/>
              </a:rPr>
              <a:t>m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'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638280" y="6896160"/>
            <a:ext cx="5670360" cy="89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dditional file 2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easurements of (a) 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o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(dotted lines) and 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m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(solid lines), and (b) 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' (dotted lines) and 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m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' (solid lines) during progression of drought. Measurements are shown for Columbia (◊), Landsberg (□) and C24 (Δ) plants; filled symbols represent controls, empty symbols represent drought-treated plants. For both control and drought-treated populations,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n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= 8 for each line; for clarity, only measurements from 4 control and 4 drought specimens of each line are displaye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223920" y="1241280"/>
          <a:ext cx="3295440" cy="56959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3920" y="1241280"/>
                    <a:ext cx="3295440" cy="5695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6" name=""/>
          <p:cNvGraphicFramePr/>
          <p:nvPr/>
        </p:nvGraphicFramePr>
        <p:xfrm>
          <a:off x="3249720" y="1241280"/>
          <a:ext cx="3295440" cy="569592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7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249720" y="1241280"/>
                    <a:ext cx="3295440" cy="5695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nicola.collingwood</cp:lastModifiedBy>
  <dcterms:modified xsi:type="dcterms:W3CDTF">2008-10-09T13:21:21Z</dcterms:modified>
  <cp:revision>8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